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A9C62C-E614-4AD9-B019-FE7501B9900C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863CD1-B848-45E2-9FCF-ACEDD3541A0A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D075D-7FD3-44CF-BE01-A4DA018783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37F44-B528-43FB-B9CE-2F88BB37D2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76A71-F093-4659-9F7F-226529F83B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5BBF9-677D-4446-A6CB-FC7880556B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B850E-2F9D-4BED-80B8-1DD53A2E14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822C7-9882-4042-859A-BF201D9B74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24250-2FD3-44CD-9A57-5389FA32EF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8C7D69-B382-4C80-9C92-ABE5CB79F1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F38DB-851B-426F-8F45-69C8A23536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F8322-7DE1-4720-B5AB-031487D32F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07929-CB4B-4D82-9B8A-D8D0D0001E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0BF08-DDC6-4B7F-99D6-E14690873F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9AFD4B-448F-4541-887B-61CF5903A20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6"/>
          <p:cNvGrpSpPr/>
          <p:nvPr/>
        </p:nvGrpSpPr>
        <p:grpSpPr>
          <a:xfrm>
            <a:off x="642960" y="1036800"/>
            <a:ext cx="5572080" cy="4833360"/>
            <a:chOff x="642960" y="1036800"/>
            <a:chExt cx="5572080" cy="4833360"/>
          </a:xfrm>
        </p:grpSpPr>
        <p:sp>
          <p:nvSpPr>
            <p:cNvPr id="49" name="TextBox 56"/>
            <p:cNvSpPr/>
            <p:nvPr/>
          </p:nvSpPr>
          <p:spPr>
            <a:xfrm>
              <a:off x="642960" y="196164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&amp;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0" name="Group 71"/>
            <p:cNvGrpSpPr/>
            <p:nvPr/>
          </p:nvGrpSpPr>
          <p:grpSpPr>
            <a:xfrm>
              <a:off x="5500800" y="3352680"/>
              <a:ext cx="714240" cy="1675080"/>
              <a:chOff x="5500800" y="3352680"/>
              <a:chExt cx="714240" cy="1675080"/>
            </a:xfrm>
          </p:grpSpPr>
          <p:sp>
            <p:nvSpPr>
              <p:cNvPr id="51" name="TextBox 57"/>
              <p:cNvSpPr/>
              <p:nvPr/>
            </p:nvSpPr>
            <p:spPr>
              <a:xfrm>
                <a:off x="5500800" y="4781520"/>
                <a:ext cx="71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</a:t>
                </a: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β</a:t>
                </a: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TextBox 58"/>
              <p:cNvSpPr/>
              <p:nvPr/>
            </p:nvSpPr>
            <p:spPr>
              <a:xfrm>
                <a:off x="5500800" y="3352680"/>
                <a:ext cx="71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l IV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TextBox 59"/>
            <p:cNvSpPr/>
            <p:nvPr/>
          </p:nvSpPr>
          <p:spPr>
            <a:xfrm>
              <a:off x="642960" y="496296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E1/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60"/>
            <p:cNvSpPr/>
            <p:nvPr/>
          </p:nvSpPr>
          <p:spPr>
            <a:xfrm>
              <a:off x="642960" y="3390840"/>
              <a:ext cx="71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i6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5" name="Picture 6" descr="1 b"/>
            <p:cNvPicPr/>
            <p:nvPr/>
          </p:nvPicPr>
          <p:blipFill>
            <a:blip r:embed="rId1"/>
            <a:stretch/>
          </p:blipFill>
          <p:spPr>
            <a:xfrm>
              <a:off x="1425960" y="1358640"/>
              <a:ext cx="1968480" cy="147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8" descr="cal27 ki677.jpg"/>
            <p:cNvPicPr/>
            <p:nvPr/>
          </p:nvPicPr>
          <p:blipFill>
            <a:blip r:embed="rId2">
              <a:lum bright="20000"/>
            </a:blip>
            <a:stretch/>
          </p:blipFill>
          <p:spPr>
            <a:xfrm>
              <a:off x="1424880" y="2860920"/>
              <a:ext cx="1968480" cy="1476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9" descr="cal27 AE1323.jpg"/>
            <p:cNvPicPr/>
            <p:nvPr/>
          </p:nvPicPr>
          <p:blipFill>
            <a:blip r:embed="rId3"/>
            <a:stretch/>
          </p:blipFill>
          <p:spPr>
            <a:xfrm>
              <a:off x="1424880" y="4350960"/>
              <a:ext cx="1968480" cy="147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20"/>
            <p:cNvSpPr/>
            <p:nvPr/>
          </p:nvSpPr>
          <p:spPr>
            <a:xfrm>
              <a:off x="1400400" y="4011480"/>
              <a:ext cx="35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4"/>
            <p:cNvSpPr/>
            <p:nvPr/>
          </p:nvSpPr>
          <p:spPr>
            <a:xfrm>
              <a:off x="1400400" y="5512320"/>
              <a:ext cx="35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8"/>
            <p:cNvSpPr/>
            <p:nvPr/>
          </p:nvSpPr>
          <p:spPr>
            <a:xfrm>
              <a:off x="1400400" y="2515320"/>
              <a:ext cx="357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68"/>
            <p:cNvSpPr/>
            <p:nvPr/>
          </p:nvSpPr>
          <p:spPr>
            <a:xfrm>
              <a:off x="2757960" y="5726160"/>
              <a:ext cx="571320" cy="2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69"/>
            <p:cNvSpPr/>
            <p:nvPr/>
          </p:nvSpPr>
          <p:spPr>
            <a:xfrm>
              <a:off x="2757960" y="4225680"/>
              <a:ext cx="5713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Straight Connector 70"/>
            <p:cNvSpPr/>
            <p:nvPr/>
          </p:nvSpPr>
          <p:spPr>
            <a:xfrm>
              <a:off x="2757960" y="2724840"/>
              <a:ext cx="571320" cy="14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4" name="Group 66"/>
            <p:cNvGrpSpPr/>
            <p:nvPr/>
          </p:nvGrpSpPr>
          <p:grpSpPr>
            <a:xfrm>
              <a:off x="3400920" y="2865600"/>
              <a:ext cx="1992960" cy="3004560"/>
              <a:chOff x="3400920" y="2865600"/>
              <a:chExt cx="1992960" cy="3004560"/>
            </a:xfrm>
          </p:grpSpPr>
          <p:pic>
            <p:nvPicPr>
              <p:cNvPr id="65" name="Picture 8" descr="cal27 ki677.jpg"/>
              <p:cNvPicPr/>
              <p:nvPr/>
            </p:nvPicPr>
            <p:blipFill>
              <a:blip r:embed="rId4">
                <a:lum bright="20000"/>
              </a:blip>
              <a:stretch/>
            </p:blipFill>
            <p:spPr>
              <a:xfrm>
                <a:off x="3425040" y="2865600"/>
                <a:ext cx="1968840" cy="1476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6" name="Picture 8" descr="cal27 ki677.jpg"/>
              <p:cNvPicPr/>
              <p:nvPr/>
            </p:nvPicPr>
            <p:blipFill>
              <a:blip r:embed="rId5"/>
              <a:stretch/>
            </p:blipFill>
            <p:spPr>
              <a:xfrm>
                <a:off x="3425040" y="4360320"/>
                <a:ext cx="1968840" cy="1476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7" name="TextBox 21"/>
              <p:cNvSpPr/>
              <p:nvPr/>
            </p:nvSpPr>
            <p:spPr>
              <a:xfrm>
                <a:off x="3400920" y="402120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D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TextBox 40"/>
              <p:cNvSpPr/>
              <p:nvPr/>
            </p:nvSpPr>
            <p:spPr>
              <a:xfrm>
                <a:off x="3400920" y="5593680"/>
                <a:ext cx="357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Calibri"/>
                  </a:rPr>
                  <a:t>E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Straight Connector 67"/>
              <p:cNvSpPr/>
              <p:nvPr/>
            </p:nvSpPr>
            <p:spPr>
              <a:xfrm>
                <a:off x="4758480" y="5737320"/>
                <a:ext cx="5713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Straight Connector 75"/>
              <p:cNvSpPr/>
              <p:nvPr/>
            </p:nvSpPr>
            <p:spPr>
              <a:xfrm>
                <a:off x="4758480" y="4236480"/>
                <a:ext cx="571320" cy="144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1" name="TextBox 55"/>
            <p:cNvSpPr/>
            <p:nvPr/>
          </p:nvSpPr>
          <p:spPr>
            <a:xfrm>
              <a:off x="1478520" y="1036800"/>
              <a:ext cx="177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DOM DOK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TextBox 59"/>
          <p:cNvSpPr/>
          <p:nvPr/>
        </p:nvSpPr>
        <p:spPr>
          <a:xfrm>
            <a:off x="266760" y="1634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25"/>
          <p:cNvSpPr/>
          <p:nvPr/>
        </p:nvSpPr>
        <p:spPr>
          <a:xfrm>
            <a:off x="685800" y="6210360"/>
            <a:ext cx="54864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F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TEDOM were generated by culturing DOK and normal oral fibroblasts on DED at an air-to-liquid interface for 14 days. Sections were stained with H&amp;E (A) and immunohistochemically stained to show the pattern of expression of Ki67 (B), AE1/3 (C), Collagen type IV (D) and integrin αvβ6 (E) and counterstained with haematoxylin. Scale bar = 200 µm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7T19:52:16Z</dcterms:created>
  <dc:creator>helen colley</dc:creator>
  <dc:description/>
  <dc:language>en-US</dc:language>
  <cp:lastModifiedBy>j.jagadheesh</cp:lastModifiedBy>
  <dcterms:modified xsi:type="dcterms:W3CDTF">2011-10-05T14:31:46Z</dcterms:modified>
  <cp:revision>17</cp:revision>
  <dc:subject/>
  <dc:title>Slide 1</dc:title>
</cp:coreProperties>
</file>